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de-DE"/>
    </a:defPPr>
    <a:lvl1pPr marL="0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1pPr>
    <a:lvl2pPr marL="519196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2pPr>
    <a:lvl3pPr marL="1038393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3pPr>
    <a:lvl4pPr marL="1557589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4pPr>
    <a:lvl5pPr marL="2076785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5pPr>
    <a:lvl6pPr marL="2595982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6pPr>
    <a:lvl7pPr marL="3115178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7pPr>
    <a:lvl8pPr marL="3634374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8pPr>
    <a:lvl9pPr marL="4153571" algn="l" defTabSz="1038393" rtl="0" eaLnBrk="1" latinLnBrk="0" hangingPunct="1">
      <a:defRPr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9" d="100"/>
          <a:sy n="99" d="100"/>
        </p:scale>
        <p:origin x="-2970" y="-72"/>
      </p:cViewPr>
      <p:guideLst>
        <p:guide orient="horz" pos="3120"/>
        <p:guide pos="21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2" y="3077283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191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383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575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767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959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151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343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535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9829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0559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48" y="396700"/>
            <a:ext cx="1543051" cy="845220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1" y="396700"/>
            <a:ext cx="4514850" cy="8452203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7942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1420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5"/>
            <a:ext cx="5829300" cy="1967442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1919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3839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5758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767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59598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1517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3437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5357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18600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1" y="2311401"/>
            <a:ext cx="3028950" cy="6537502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2" y="2311401"/>
            <a:ext cx="3028950" cy="6537502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3168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6"/>
            <a:ext cx="3030142" cy="924101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9196" indent="0">
              <a:buNone/>
              <a:defRPr sz="2300" b="1"/>
            </a:lvl2pPr>
            <a:lvl3pPr marL="1038393" indent="0">
              <a:buNone/>
              <a:defRPr sz="2000" b="1"/>
            </a:lvl3pPr>
            <a:lvl4pPr marL="1557589" indent="0">
              <a:buNone/>
              <a:defRPr sz="1800" b="1"/>
            </a:lvl4pPr>
            <a:lvl5pPr marL="2076785" indent="0">
              <a:buNone/>
              <a:defRPr sz="1800" b="1"/>
            </a:lvl5pPr>
            <a:lvl6pPr marL="2595982" indent="0">
              <a:buNone/>
              <a:defRPr sz="1800" b="1"/>
            </a:lvl6pPr>
            <a:lvl7pPr marL="3115178" indent="0">
              <a:buNone/>
              <a:defRPr sz="1800" b="1"/>
            </a:lvl7pPr>
            <a:lvl8pPr marL="3634374" indent="0">
              <a:buNone/>
              <a:defRPr sz="1800" b="1"/>
            </a:lvl8pPr>
            <a:lvl9pPr marL="4153571" indent="0">
              <a:buNone/>
              <a:defRPr sz="18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7"/>
            <a:ext cx="3030142" cy="5707417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6"/>
            <a:ext cx="3031331" cy="924101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9196" indent="0">
              <a:buNone/>
              <a:defRPr sz="2300" b="1"/>
            </a:lvl2pPr>
            <a:lvl3pPr marL="1038393" indent="0">
              <a:buNone/>
              <a:defRPr sz="2000" b="1"/>
            </a:lvl3pPr>
            <a:lvl4pPr marL="1557589" indent="0">
              <a:buNone/>
              <a:defRPr sz="1800" b="1"/>
            </a:lvl4pPr>
            <a:lvl5pPr marL="2076785" indent="0">
              <a:buNone/>
              <a:defRPr sz="1800" b="1"/>
            </a:lvl5pPr>
            <a:lvl6pPr marL="2595982" indent="0">
              <a:buNone/>
              <a:defRPr sz="1800" b="1"/>
            </a:lvl6pPr>
            <a:lvl7pPr marL="3115178" indent="0">
              <a:buNone/>
              <a:defRPr sz="1800" b="1"/>
            </a:lvl7pPr>
            <a:lvl8pPr marL="3634374" indent="0">
              <a:buNone/>
              <a:defRPr sz="1800" b="1"/>
            </a:lvl8pPr>
            <a:lvl9pPr marL="4153571" indent="0">
              <a:buNone/>
              <a:defRPr sz="18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7"/>
            <a:ext cx="3031331" cy="5707417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3734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5858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6622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2" y="394407"/>
            <a:ext cx="2256234" cy="1678517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2" cy="8454496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2" y="2072923"/>
            <a:ext cx="2256234" cy="6775980"/>
          </a:xfrm>
        </p:spPr>
        <p:txBody>
          <a:bodyPr/>
          <a:lstStyle>
            <a:lvl1pPr marL="0" indent="0">
              <a:buNone/>
              <a:defRPr sz="1600"/>
            </a:lvl1pPr>
            <a:lvl2pPr marL="519196" indent="0">
              <a:buNone/>
              <a:defRPr sz="1400"/>
            </a:lvl2pPr>
            <a:lvl3pPr marL="1038393" indent="0">
              <a:buNone/>
              <a:defRPr sz="1100"/>
            </a:lvl3pPr>
            <a:lvl4pPr marL="1557589" indent="0">
              <a:buNone/>
              <a:defRPr sz="1000"/>
            </a:lvl4pPr>
            <a:lvl5pPr marL="2076785" indent="0">
              <a:buNone/>
              <a:defRPr sz="1000"/>
            </a:lvl5pPr>
            <a:lvl6pPr marL="2595982" indent="0">
              <a:buNone/>
              <a:defRPr sz="1000"/>
            </a:lvl6pPr>
            <a:lvl7pPr marL="3115178" indent="0">
              <a:buNone/>
              <a:defRPr sz="1000"/>
            </a:lvl7pPr>
            <a:lvl8pPr marL="3634374" indent="0">
              <a:buNone/>
              <a:defRPr sz="1000"/>
            </a:lvl8pPr>
            <a:lvl9pPr marL="4153571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4706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7" y="6934202"/>
            <a:ext cx="4114800" cy="818621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7" y="885122"/>
            <a:ext cx="4114800" cy="5943600"/>
          </a:xfrm>
        </p:spPr>
        <p:txBody>
          <a:bodyPr/>
          <a:lstStyle>
            <a:lvl1pPr marL="0" indent="0">
              <a:buNone/>
              <a:defRPr sz="3600"/>
            </a:lvl1pPr>
            <a:lvl2pPr marL="519196" indent="0">
              <a:buNone/>
              <a:defRPr sz="3200"/>
            </a:lvl2pPr>
            <a:lvl3pPr marL="1038393" indent="0">
              <a:buNone/>
              <a:defRPr sz="2700"/>
            </a:lvl3pPr>
            <a:lvl4pPr marL="1557589" indent="0">
              <a:buNone/>
              <a:defRPr sz="2300"/>
            </a:lvl4pPr>
            <a:lvl5pPr marL="2076785" indent="0">
              <a:buNone/>
              <a:defRPr sz="2300"/>
            </a:lvl5pPr>
            <a:lvl6pPr marL="2595982" indent="0">
              <a:buNone/>
              <a:defRPr sz="2300"/>
            </a:lvl6pPr>
            <a:lvl7pPr marL="3115178" indent="0">
              <a:buNone/>
              <a:defRPr sz="2300"/>
            </a:lvl7pPr>
            <a:lvl8pPr marL="3634374" indent="0">
              <a:buNone/>
              <a:defRPr sz="2300"/>
            </a:lvl8pPr>
            <a:lvl9pPr marL="4153571" indent="0">
              <a:buNone/>
              <a:defRPr sz="23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7" y="7752822"/>
            <a:ext cx="4114800" cy="1162579"/>
          </a:xfrm>
        </p:spPr>
        <p:txBody>
          <a:bodyPr/>
          <a:lstStyle>
            <a:lvl1pPr marL="0" indent="0">
              <a:buNone/>
              <a:defRPr sz="1600"/>
            </a:lvl1pPr>
            <a:lvl2pPr marL="519196" indent="0">
              <a:buNone/>
              <a:defRPr sz="1400"/>
            </a:lvl2pPr>
            <a:lvl3pPr marL="1038393" indent="0">
              <a:buNone/>
              <a:defRPr sz="1100"/>
            </a:lvl3pPr>
            <a:lvl4pPr marL="1557589" indent="0">
              <a:buNone/>
              <a:defRPr sz="1000"/>
            </a:lvl4pPr>
            <a:lvl5pPr marL="2076785" indent="0">
              <a:buNone/>
              <a:defRPr sz="1000"/>
            </a:lvl5pPr>
            <a:lvl6pPr marL="2595982" indent="0">
              <a:buNone/>
              <a:defRPr sz="1000"/>
            </a:lvl6pPr>
            <a:lvl7pPr marL="3115178" indent="0">
              <a:buNone/>
              <a:defRPr sz="1000"/>
            </a:lvl7pPr>
            <a:lvl8pPr marL="3634374" indent="0">
              <a:buNone/>
              <a:defRPr sz="1000"/>
            </a:lvl8pPr>
            <a:lvl9pPr marL="4153571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0341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3839" tIns="51920" rIns="103839" bIns="519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2"/>
          </a:xfrm>
          <a:prstGeom prst="rect">
            <a:avLst/>
          </a:prstGeom>
        </p:spPr>
        <p:txBody>
          <a:bodyPr vert="horz" lIns="103839" tIns="51920" rIns="103839" bIns="519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2" y="9181395"/>
            <a:ext cx="1600199" cy="527403"/>
          </a:xfrm>
          <a:prstGeom prst="rect">
            <a:avLst/>
          </a:prstGeom>
        </p:spPr>
        <p:txBody>
          <a:bodyPr vert="horz" lIns="103839" tIns="51920" rIns="103839" bIns="51920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451FAA-5A0C-4932-A772-4EFE5C6E955C}" type="datetimeFigureOut">
              <a:rPr lang="de-DE" smtClean="0"/>
              <a:t>12.06.2018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1" cy="527403"/>
          </a:xfrm>
          <a:prstGeom prst="rect">
            <a:avLst/>
          </a:prstGeom>
        </p:spPr>
        <p:txBody>
          <a:bodyPr vert="horz" lIns="103839" tIns="51920" rIns="103839" bIns="51920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3" y="9181395"/>
            <a:ext cx="1600199" cy="527403"/>
          </a:xfrm>
          <a:prstGeom prst="rect">
            <a:avLst/>
          </a:prstGeom>
        </p:spPr>
        <p:txBody>
          <a:bodyPr vert="horz" lIns="103839" tIns="51920" rIns="103839" bIns="51920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EE7A1-2F8B-417A-8BB5-A410FDB900C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7924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38393" rtl="0" eaLnBrk="1" latinLnBrk="0" hangingPunct="1">
        <a:spcBef>
          <a:spcPct val="0"/>
        </a:spcBef>
        <a:buNone/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9397" indent="-389397" algn="l" defTabSz="1038393" rtl="0" eaLnBrk="1" latinLnBrk="0" hangingPunct="1">
        <a:spcBef>
          <a:spcPct val="20000"/>
        </a:spcBef>
        <a:buFont typeface="Arial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43694" indent="-324498" algn="l" defTabSz="1038393" rtl="0" eaLnBrk="1" latinLnBrk="0" hangingPunct="1">
        <a:spcBef>
          <a:spcPct val="20000"/>
        </a:spcBef>
        <a:buFont typeface="Arial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297991" indent="-259598" algn="l" defTabSz="1038393" rtl="0" eaLnBrk="1" latinLnBrk="0" hangingPunct="1">
        <a:spcBef>
          <a:spcPct val="20000"/>
        </a:spcBef>
        <a:buFont typeface="Arial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17187" indent="-259598" algn="l" defTabSz="1038393" rtl="0" eaLnBrk="1" latinLnBrk="0" hangingPunct="1">
        <a:spcBef>
          <a:spcPct val="20000"/>
        </a:spcBef>
        <a:buFont typeface="Arial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36383" indent="-259598" algn="l" defTabSz="1038393" rtl="0" eaLnBrk="1" latinLnBrk="0" hangingPunct="1">
        <a:spcBef>
          <a:spcPct val="20000"/>
        </a:spcBef>
        <a:buFont typeface="Arial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55580" indent="-259598" algn="l" defTabSz="103839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74776" indent="-259598" algn="l" defTabSz="103839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893972" indent="-259598" algn="l" defTabSz="103839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13169" indent="-259598" algn="l" defTabSz="103839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19196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38393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557589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76785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95982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115178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634374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153571" algn="l" defTabSz="1038393" rtl="0" eaLnBrk="1" latinLnBrk="0" hangingPunct="1"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2" y="5622226"/>
            <a:ext cx="2104308" cy="2107317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2" y="3120939"/>
            <a:ext cx="2129869" cy="2107317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2696" y="3120939"/>
            <a:ext cx="2129869" cy="2107317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3245" y="5622226"/>
            <a:ext cx="2129869" cy="2107317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2696" y="664677"/>
            <a:ext cx="2129869" cy="2107317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5349" y="5622226"/>
            <a:ext cx="2129869" cy="2107317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5349" y="3120939"/>
            <a:ext cx="2129869" cy="2107317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2" y="7700845"/>
            <a:ext cx="2129869" cy="2107317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3245" y="7700845"/>
            <a:ext cx="2129869" cy="2107317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02" y="664677"/>
            <a:ext cx="2129869" cy="2107317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5349" y="664677"/>
            <a:ext cx="2104308" cy="2107317"/>
          </a:xfrm>
          <a:prstGeom prst="rect">
            <a:avLst/>
          </a:prstGeom>
        </p:spPr>
      </p:pic>
      <p:cxnSp>
        <p:nvCxnSpPr>
          <p:cNvPr id="16" name="Gerade Verbindung 15"/>
          <p:cNvCxnSpPr/>
          <p:nvPr/>
        </p:nvCxnSpPr>
        <p:spPr>
          <a:xfrm>
            <a:off x="0" y="664677"/>
            <a:ext cx="6858000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feld 148"/>
          <p:cNvSpPr txBox="1"/>
          <p:nvPr/>
        </p:nvSpPr>
        <p:spPr>
          <a:xfrm>
            <a:off x="-27481" y="5942"/>
            <a:ext cx="746713" cy="320298"/>
          </a:xfrm>
          <a:prstGeom prst="rect">
            <a:avLst/>
          </a:prstGeom>
          <a:noFill/>
        </p:spPr>
        <p:txBody>
          <a:bodyPr wrap="none" lIns="103839" tIns="51920" rIns="103839" bIns="51920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r>
              <a:rPr lang="de-DE" sz="1400" b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2245003" y="327469"/>
            <a:ext cx="2351767" cy="289520"/>
          </a:xfrm>
          <a:prstGeom prst="rect">
            <a:avLst/>
          </a:prstGeom>
          <a:noFill/>
        </p:spPr>
        <p:txBody>
          <a:bodyPr wrap="none" lIns="103839" tIns="51920" rIns="103839" bIns="51920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mokine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ffect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BDL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Gerade Verbindung 149"/>
          <p:cNvCxnSpPr/>
          <p:nvPr/>
        </p:nvCxnSpPr>
        <p:spPr>
          <a:xfrm>
            <a:off x="-9070" y="3114440"/>
            <a:ext cx="6858000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feld 150"/>
          <p:cNvSpPr txBox="1"/>
          <p:nvPr/>
        </p:nvSpPr>
        <p:spPr>
          <a:xfrm>
            <a:off x="1841963" y="2774386"/>
            <a:ext cx="3194498" cy="289520"/>
          </a:xfrm>
          <a:prstGeom prst="rect">
            <a:avLst/>
          </a:prstGeom>
          <a:noFill/>
        </p:spPr>
        <p:txBody>
          <a:bodyPr wrap="none" lIns="103839" tIns="51920" rIns="103839" bIns="51920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mokine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ffected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MCMV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fec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Gerade Verbindung 151"/>
          <p:cNvCxnSpPr/>
          <p:nvPr/>
        </p:nvCxnSpPr>
        <p:spPr>
          <a:xfrm>
            <a:off x="0" y="5627676"/>
            <a:ext cx="6858000" cy="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feld 152"/>
          <p:cNvSpPr txBox="1"/>
          <p:nvPr/>
        </p:nvSpPr>
        <p:spPr>
          <a:xfrm>
            <a:off x="2659384" y="5321401"/>
            <a:ext cx="1525772" cy="289520"/>
          </a:xfrm>
          <a:prstGeom prst="rect">
            <a:avLst/>
          </a:prstGeom>
          <a:noFill/>
        </p:spPr>
        <p:txBody>
          <a:bodyPr wrap="none" lIns="103839" tIns="51920" rIns="103839" bIns="51920" rtlCol="0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hemokines</a:t>
            </a:r>
            <a:endParaRPr lang="de-DE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7429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</Words>
  <Application>Microsoft Office PowerPoint</Application>
  <PresentationFormat>A4-Papier (210x297 mm)</PresentationFormat>
  <Paragraphs>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K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KS</dc:creator>
  <cp:lastModifiedBy>alzi</cp:lastModifiedBy>
  <cp:revision>16</cp:revision>
  <dcterms:created xsi:type="dcterms:W3CDTF">2016-11-18T13:06:40Z</dcterms:created>
  <dcterms:modified xsi:type="dcterms:W3CDTF">2018-06-12T17:25:52Z</dcterms:modified>
</cp:coreProperties>
</file>